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77" r:id="rId2"/>
    <p:sldId id="278" r:id="rId3"/>
    <p:sldId id="276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04" d="100"/>
          <a:sy n="104" d="100"/>
        </p:scale>
        <p:origin x="6906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>
            <a:extLst>
              <a:ext uri="{FF2B5EF4-FFF2-40B4-BE49-F238E27FC236}">
                <a16:creationId xmlns:a16="http://schemas.microsoft.com/office/drawing/2014/main" id="{9E2F22ED-8738-4084-B32A-90999BE339A3}"/>
              </a:ext>
            </a:extLst>
          </p:cNvPr>
          <p:cNvGrpSpPr/>
          <p:nvPr/>
        </p:nvGrpSpPr>
        <p:grpSpPr>
          <a:xfrm>
            <a:off x="660004" y="254900"/>
            <a:ext cx="5256701" cy="9286870"/>
            <a:chOff x="660004" y="254900"/>
            <a:chExt cx="5256701" cy="9286870"/>
          </a:xfrm>
        </p:grpSpPr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F66254D5-0CC3-4618-9021-A167B6154C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512" b="7773"/>
            <a:stretch/>
          </p:blipFill>
          <p:spPr>
            <a:xfrm>
              <a:off x="1075764" y="7270376"/>
              <a:ext cx="4840941" cy="2061883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E318126E-B6C3-4AEB-A0DD-0F0E63B25E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512" b="7773"/>
            <a:stretch/>
          </p:blipFill>
          <p:spPr>
            <a:xfrm>
              <a:off x="1075766" y="4661647"/>
              <a:ext cx="4831976" cy="1936378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97D3BCAC-D4F8-4751-A04A-D11DA06F03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72" b="7353"/>
            <a:stretch/>
          </p:blipFill>
          <p:spPr>
            <a:xfrm>
              <a:off x="1084729" y="443747"/>
              <a:ext cx="4814047" cy="3626229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935F502-5FD9-46DB-A835-F2317BAC7292}"/>
                </a:ext>
              </a:extLst>
            </p:cNvPr>
            <p:cNvSpPr txBox="1"/>
            <p:nvPr/>
          </p:nvSpPr>
          <p:spPr>
            <a:xfrm>
              <a:off x="2293178" y="254900"/>
              <a:ext cx="282409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photosynthesis pathway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4AC8D6B7-9698-48A0-B321-79CB046FDD36}"/>
                </a:ext>
              </a:extLst>
            </p:cNvPr>
            <p:cNvSpPr txBox="1"/>
            <p:nvPr/>
          </p:nvSpPr>
          <p:spPr>
            <a:xfrm>
              <a:off x="668018" y="362622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22DE4350-2C5E-4CB3-9854-F431C4C04435}"/>
                </a:ext>
              </a:extLst>
            </p:cNvPr>
            <p:cNvSpPr txBox="1"/>
            <p:nvPr/>
          </p:nvSpPr>
          <p:spPr>
            <a:xfrm>
              <a:off x="1763025" y="4048468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4B51A7FE-B119-4CD6-9554-75DC3503B259}"/>
                </a:ext>
              </a:extLst>
            </p:cNvPr>
            <p:cNvSpPr txBox="1"/>
            <p:nvPr/>
          </p:nvSpPr>
          <p:spPr>
            <a:xfrm>
              <a:off x="2293178" y="4484000"/>
              <a:ext cx="282409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as photosystem I components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041BDCA-3A34-408A-A3EF-01A51F665BAC}"/>
                </a:ext>
              </a:extLst>
            </p:cNvPr>
            <p:cNvSpPr txBox="1"/>
            <p:nvPr/>
          </p:nvSpPr>
          <p:spPr>
            <a:xfrm>
              <a:off x="668018" y="4591722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F2B73D39-A8BE-4D47-A929-BDCADF4EBA72}"/>
                </a:ext>
              </a:extLst>
            </p:cNvPr>
            <p:cNvSpPr txBox="1"/>
            <p:nvPr/>
          </p:nvSpPr>
          <p:spPr>
            <a:xfrm>
              <a:off x="1763025" y="6592747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EFFE706C-DEBA-481C-9B97-C948493E0531}"/>
                </a:ext>
              </a:extLst>
            </p:cNvPr>
            <p:cNvSpPr txBox="1"/>
            <p:nvPr/>
          </p:nvSpPr>
          <p:spPr>
            <a:xfrm>
              <a:off x="2293178" y="7112804"/>
              <a:ext cx="282409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as photosystem II components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A2DCE7EE-33EC-4EB0-A533-16FF0DDDFD10}"/>
                </a:ext>
              </a:extLst>
            </p:cNvPr>
            <p:cNvSpPr txBox="1"/>
            <p:nvPr/>
          </p:nvSpPr>
          <p:spPr>
            <a:xfrm>
              <a:off x="660004" y="7220526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393CFA17-51B1-4615-A78C-79AE62DC4AA7}"/>
                </a:ext>
              </a:extLst>
            </p:cNvPr>
            <p:cNvSpPr txBox="1"/>
            <p:nvPr/>
          </p:nvSpPr>
          <p:spPr>
            <a:xfrm>
              <a:off x="1772550" y="9326326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932590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>
            <a:extLst>
              <a:ext uri="{FF2B5EF4-FFF2-40B4-BE49-F238E27FC236}">
                <a16:creationId xmlns:a16="http://schemas.microsoft.com/office/drawing/2014/main" id="{A44D3C87-2C93-44E5-A885-7193C5CFF2F8}"/>
              </a:ext>
            </a:extLst>
          </p:cNvPr>
          <p:cNvGrpSpPr/>
          <p:nvPr/>
        </p:nvGrpSpPr>
        <p:grpSpPr>
          <a:xfrm>
            <a:off x="668018" y="321236"/>
            <a:ext cx="5248689" cy="9041002"/>
            <a:chOff x="668018" y="321236"/>
            <a:chExt cx="5248689" cy="9041002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D626EEE1-546A-4872-A1A1-B07D0FEDFD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72" b="7633"/>
            <a:stretch/>
          </p:blipFill>
          <p:spPr>
            <a:xfrm>
              <a:off x="1039906" y="7557247"/>
              <a:ext cx="4858871" cy="1595718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89AE0FD5-68E9-4BC4-BB0F-C880EBF118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39" b="7547"/>
            <a:stretch/>
          </p:blipFill>
          <p:spPr>
            <a:xfrm>
              <a:off x="1066801" y="4356848"/>
              <a:ext cx="4849906" cy="2635624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E08FA6A7-DC80-4953-A317-3622B6269B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32" b="7773"/>
            <a:stretch/>
          </p:blipFill>
          <p:spPr>
            <a:xfrm>
              <a:off x="1075765" y="484094"/>
              <a:ext cx="4823012" cy="3379694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47D022C8-2AB5-40D4-922B-08BDEF8538E8}"/>
                </a:ext>
              </a:extLst>
            </p:cNvPr>
            <p:cNvSpPr txBox="1"/>
            <p:nvPr/>
          </p:nvSpPr>
          <p:spPr>
            <a:xfrm>
              <a:off x="1994591" y="321236"/>
              <a:ext cx="347897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photosynthesis-antenna proteins pathway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366C53D0-BADA-460D-882A-7777B07000AE}"/>
                </a:ext>
              </a:extLst>
            </p:cNvPr>
            <p:cNvSpPr txBox="1"/>
            <p:nvPr/>
          </p:nvSpPr>
          <p:spPr>
            <a:xfrm>
              <a:off x="668018" y="362622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F68D4E1-52EB-441F-9C21-CC4CFFDF693A}"/>
                </a:ext>
              </a:extLst>
            </p:cNvPr>
            <p:cNvSpPr txBox="1"/>
            <p:nvPr/>
          </p:nvSpPr>
          <p:spPr>
            <a:xfrm>
              <a:off x="1763024" y="3881187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CF83655-08B1-4247-A20B-2C9781813BCD}"/>
                </a:ext>
              </a:extLst>
            </p:cNvPr>
            <p:cNvSpPr txBox="1"/>
            <p:nvPr/>
          </p:nvSpPr>
          <p:spPr>
            <a:xfrm>
              <a:off x="1975540" y="4169336"/>
              <a:ext cx="361687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porphyrin and chlorophyll metabolism pathway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2E9D1DD-820D-4126-B5C0-87426E48AA19}"/>
                </a:ext>
              </a:extLst>
            </p:cNvPr>
            <p:cNvSpPr txBox="1"/>
            <p:nvPr/>
          </p:nvSpPr>
          <p:spPr>
            <a:xfrm>
              <a:off x="668018" y="4182147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993C243-F1F1-43B9-B4C1-B55F95AA3B4D}"/>
                </a:ext>
              </a:extLst>
            </p:cNvPr>
            <p:cNvSpPr txBox="1"/>
            <p:nvPr/>
          </p:nvSpPr>
          <p:spPr>
            <a:xfrm>
              <a:off x="1763024" y="6976784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5D78293-A016-4B5C-A208-1DA451AF0577}"/>
                </a:ext>
              </a:extLst>
            </p:cNvPr>
            <p:cNvSpPr txBox="1"/>
            <p:nvPr/>
          </p:nvSpPr>
          <p:spPr>
            <a:xfrm>
              <a:off x="1965326" y="7364987"/>
              <a:ext cx="361687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carotenoid biosynthesis pathway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FA4B522F-D5FF-421E-96B9-6F01B60AC129}"/>
                </a:ext>
              </a:extLst>
            </p:cNvPr>
            <p:cNvSpPr txBox="1"/>
            <p:nvPr/>
          </p:nvSpPr>
          <p:spPr>
            <a:xfrm>
              <a:off x="693593" y="7433598"/>
              <a:ext cx="2712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B5969D3-399F-4366-A007-ABF677013BEC}"/>
                </a:ext>
              </a:extLst>
            </p:cNvPr>
            <p:cNvSpPr txBox="1"/>
            <p:nvPr/>
          </p:nvSpPr>
          <p:spPr>
            <a:xfrm>
              <a:off x="1802714" y="9146794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485497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3BCD1299-FAFA-4C8B-96EE-E4DC481074E0}"/>
              </a:ext>
            </a:extLst>
          </p:cNvPr>
          <p:cNvGrpSpPr/>
          <p:nvPr/>
        </p:nvGrpSpPr>
        <p:grpSpPr>
          <a:xfrm>
            <a:off x="668019" y="321236"/>
            <a:ext cx="5257652" cy="4480839"/>
            <a:chOff x="668019" y="321236"/>
            <a:chExt cx="5257652" cy="4480839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E54E0DBD-2336-49A1-86EB-864111532C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32" b="7633"/>
            <a:stretch/>
          </p:blipFill>
          <p:spPr>
            <a:xfrm>
              <a:off x="1111624" y="488569"/>
              <a:ext cx="4814047" cy="4128255"/>
            </a:xfrm>
            <a:prstGeom prst="rect">
              <a:avLst/>
            </a:prstGeom>
          </p:spPr>
        </p:pic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B1D3EECF-D91E-48CC-8738-A9325BB34BC4}"/>
                </a:ext>
              </a:extLst>
            </p:cNvPr>
            <p:cNvSpPr txBox="1"/>
            <p:nvPr/>
          </p:nvSpPr>
          <p:spPr>
            <a:xfrm>
              <a:off x="1834935" y="321236"/>
              <a:ext cx="389373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nnotated in carbon fixation in photosynthetic organisms pathway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E4E40E6-84F6-4BBE-BBD9-8185605234AD}"/>
                </a:ext>
              </a:extLst>
            </p:cNvPr>
            <p:cNvSpPr txBox="1"/>
            <p:nvPr/>
          </p:nvSpPr>
          <p:spPr>
            <a:xfrm>
              <a:off x="668019" y="492579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672B891-6A5C-433D-A499-B022B8B9C138}"/>
                </a:ext>
              </a:extLst>
            </p:cNvPr>
            <p:cNvSpPr txBox="1"/>
            <p:nvPr/>
          </p:nvSpPr>
          <p:spPr>
            <a:xfrm>
              <a:off x="1780954" y="4586631"/>
              <a:ext cx="39421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0min              R1min              R30min            R45min                R6h                 R1d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856CD3E2-D9F2-422D-8C4D-7419D4D4910D}"/>
              </a:ext>
            </a:extLst>
          </p:cNvPr>
          <p:cNvSpPr txBox="1"/>
          <p:nvPr/>
        </p:nvSpPr>
        <p:spPr>
          <a:xfrm>
            <a:off x="252132" y="4825962"/>
            <a:ext cx="653302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9. Relative expression levels of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proteins related to photosynthesis and chloroplast components during rehydration in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photosynthesis-related genes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components of photosystem I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components of photosystem II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ntenna components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porphyrin and chlorophyll metabolism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carotenoid biosynthesis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G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carbon fixation. 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9018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9</TotalTime>
  <Words>166</Words>
  <Application>Microsoft Office PowerPoint</Application>
  <PresentationFormat>A4 纸张(210x297 毫米)</PresentationFormat>
  <Paragraphs>2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198</cp:revision>
  <dcterms:created xsi:type="dcterms:W3CDTF">2021-01-19T12:49:28Z</dcterms:created>
  <dcterms:modified xsi:type="dcterms:W3CDTF">2023-01-10T11:15:51Z</dcterms:modified>
</cp:coreProperties>
</file>